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xr\Desktop\&#35838;&#39064;\5.&#23454;&#39564;&#25968;&#25454;\qPCR\HpaII\2018-5-9%20%20HpaII%20and%20copy%20number%20for%20DaxxKO(Rep3-2)%20%20-%20%20Quantification%20Cq%20Results--has%20problem,%20Copy%20is%20O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xr\Desktop\&#35838;&#39064;\1.&#29983;&#29289;&#20449;&#24687;&#20998;&#26512;\&#32467;&#26524;\&#37325;&#26032;&#20998;&#26512;&#30340;&#22270;\Model\Mode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MEF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0635023789436714"/>
          <c:y val="1.264033131602271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8588000821899379"/>
          <c:y val="0.12474285631674149"/>
          <c:w val="0.6575112112788184"/>
          <c:h val="0.814121667825232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5D4-43A9-BC39-C4D60BD2BD6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5D4-43A9-BC39-C4D60BD2BD63}"/>
              </c:ext>
            </c:extLst>
          </c:dPt>
          <c:errBars>
            <c:errBarType val="plus"/>
            <c:errValType val="cust"/>
            <c:noEndCap val="0"/>
            <c:plus>
              <c:numRef>
                <c:f>'0'!$W$12</c:f>
                <c:numCache>
                  <c:formatCode>General</c:formatCode>
                  <c:ptCount val="1"/>
                  <c:pt idx="0">
                    <c:v>0.123258719783979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0'!$W$10:$X$10</c:f>
              <c:strCache>
                <c:ptCount val="2"/>
                <c:pt idx="0">
                  <c:v>Control</c:v>
                </c:pt>
                <c:pt idx="1">
                  <c:v>Daxx-KO</c:v>
                </c:pt>
              </c:strCache>
            </c:strRef>
          </c:cat>
          <c:val>
            <c:numRef>
              <c:f>'0'!$W$11:$X$11</c:f>
              <c:numCache>
                <c:formatCode>General</c:formatCode>
                <c:ptCount val="2"/>
                <c:pt idx="0">
                  <c:v>1</c:v>
                </c:pt>
                <c:pt idx="1">
                  <c:v>1.04014553843886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5D4-43A9-BC39-C4D60BD2BD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14251279"/>
        <c:axId val="314252527"/>
      </c:barChart>
      <c:catAx>
        <c:axId val="3142512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4252527"/>
        <c:crosses val="autoZero"/>
        <c:auto val="1"/>
        <c:lblAlgn val="ctr"/>
        <c:lblOffset val="100"/>
        <c:noMultiLvlLbl val="0"/>
      </c:catAx>
      <c:valAx>
        <c:axId val="31425252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/>
                  <a:t>Relative rDNA copy number</a:t>
                </a:r>
                <a:endParaRPr lang="zh-CN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14251279"/>
        <c:crosses val="autoZero"/>
        <c:crossBetween val="between"/>
        <c:majorUnit val="0.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317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7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S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0817716258914137"/>
          <c:y val="0.14951968820035594"/>
          <c:w val="0.77711154365489543"/>
          <c:h val="0.724014325587864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476-48EA-9D29-169F96AF32B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476-48EA-9D29-169F96AF32B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476-48EA-9D29-169F96AF32BB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476-48EA-9D29-169F96AF32BB}"/>
              </c:ext>
            </c:extLst>
          </c:dPt>
          <c:cat>
            <c:strRef>
              <c:f>Sheet1!$T$15:$W$15</c:f>
              <c:strCache>
                <c:ptCount val="4"/>
                <c:pt idx="0">
                  <c:v>Control</c:v>
                </c:pt>
                <c:pt idx="1">
                  <c:v>ATRX-KO</c:v>
                </c:pt>
                <c:pt idx="2">
                  <c:v>DAXX-KO</c:v>
                </c:pt>
                <c:pt idx="3">
                  <c:v>ESET-KO</c:v>
                </c:pt>
              </c:strCache>
            </c:strRef>
          </c:cat>
          <c:val>
            <c:numRef>
              <c:f>Sheet1!$T$16:$W$16</c:f>
              <c:numCache>
                <c:formatCode>General</c:formatCode>
                <c:ptCount val="4"/>
                <c:pt idx="0">
                  <c:v>1</c:v>
                </c:pt>
                <c:pt idx="1">
                  <c:v>0.94305986523207996</c:v>
                </c:pt>
                <c:pt idx="2">
                  <c:v>1.0316188844390726</c:v>
                </c:pt>
                <c:pt idx="3">
                  <c:v>1.1136671527212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476-48EA-9D29-169F96AF32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14251279"/>
        <c:axId val="314252527"/>
      </c:barChart>
      <c:catAx>
        <c:axId val="3142512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314252527"/>
        <c:crosses val="autoZero"/>
        <c:auto val="1"/>
        <c:lblAlgn val="ctr"/>
        <c:lblOffset val="100"/>
        <c:noMultiLvlLbl val="0"/>
      </c:catAx>
      <c:valAx>
        <c:axId val="314252527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7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verage RPM level of Input </a:t>
                </a:r>
                <a:r>
                  <a:rPr lang="en-US" altLang="zh-CN" sz="700" b="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l. control</a:t>
                </a:r>
                <a:endParaRPr lang="zh-CN" altLang="en-US" sz="700" b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14251279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317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2A99F2-BDAB-4707-9EF7-29B820661B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AD9FE98-D4A5-4088-9685-396E0C7B13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B74B7C-B9CB-4BBD-81BC-A5D7EED13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1D40ED-921A-4B34-A7E6-212A58972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1BD892-71F8-4A8D-8941-D9ABB885E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8763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98FBB-0CBE-4B5B-8E06-3AA394B29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7DC8127-07FA-481A-BAD7-14D961931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5F90FA-BEF9-47AD-ADA2-635FC88F4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D2D57B-FEAF-41DA-8724-A17828C2F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04D7B9-0FC7-43BF-836E-7F5D47116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610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75F047D-4538-43A3-8600-3961DD0989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5F56116-EF76-41C4-9AD7-060DD081EB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ED5AD2-25AE-435A-9A2A-49E71ECD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378CCC-33AB-449A-A1B2-4117CC1DB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F90A67-58A9-4FD0-9A9C-2538B6CBC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9749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6A18F0-E44E-4E3E-9F82-D5B5F8C65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7AE782C-187F-4DAA-B602-5BA985A6C6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7A550D-DA14-4BD8-B93E-030DE3661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238F4A-00B5-49CC-BEDA-F9C342034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2C492A-5E44-4196-9D68-265E3187B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7808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AF4C07-80FD-4C9F-BDE0-83B63F21CE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C3928CE-6F4B-4A74-B78E-3551638C10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1E86B9-F1E6-4344-8D06-3B9931891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1D427F-CD20-4336-963E-7D2A6D861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924FC2-6C49-4193-9752-24B01B393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3858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C5309E-587B-4F82-9045-9857DB469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6DF21F-D411-4C45-B69E-C0B9B93A6B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2748CF3-1DB7-489B-A65F-EF26CAF376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F1E7F3-A227-4432-9D15-70D842D8A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295DEF-0E7F-4A65-A850-5D7B6F10D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EF27573-7D79-48C0-A267-194C0FC89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7515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6972E6-E5A6-44CA-94D3-17BA7AD48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274B3C-B798-46C8-8120-7DCAEC1BFA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4AB8DC6-BA6E-460A-802F-77B12D7CAF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006CA7A-1448-4755-8EF4-E2A15A8226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D22FF96-9382-42E9-88ED-A5CF867A59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4AE6CBA-E103-420D-9E0D-0925498E8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B926FF1-12AC-4386-B2F1-A7C532468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494B650-186F-4BEE-8266-0B3C21488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254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A4876E-5F63-4012-8732-F06016C876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A24731D-990B-4551-8C76-E05410B65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66063B9-4004-4A49-BDD7-D4CE10513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E9011BA-FB3B-4996-90EC-14BD72332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6439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DD4A7AC-6CE1-46FF-B94D-0A0AFCAE6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673CD82-3FE7-420B-A4EC-CA96F4588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BDE8B7C-E3E6-4FD9-9A09-AA2D5C8FF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25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070C9E-C0A9-4977-BD6A-5DCBE302D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DA00ED-0CDB-4700-AE0F-1A4D58B0E9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A080547-0F8A-4851-959B-155CD00FA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A3325E-F684-4DBC-B94C-7E3C8663A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8982F1-1B25-4991-ADA2-A7EC63F79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D6400D-9387-46B5-9B34-4359546CC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617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D45873-22C6-48B5-9B24-1251FBB9A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6D33F89-B12F-4D45-8147-AEAE772B9E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1099445-DA2D-46F7-B605-EB288D37B6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1FCED5-EB29-40C0-9ABB-DC2A1C4CB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A4AC750-EF32-48A6-BCE5-F11CD7119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42ACD0-4CCA-4E21-8148-B00D8A0A5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9829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54C6789-A80E-4A10-A6FF-36D798D47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E8C95F-59FD-40B0-9C58-6221E2C00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7B1DB8-411A-4576-BB69-B7D41E7C86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4342D-75C8-439B-952A-CB5EE77BF618}" type="datetimeFigureOut">
              <a:rPr lang="zh-CN" altLang="en-US" smtClean="0"/>
              <a:t>2019/8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74C852-A927-4AE6-B41A-63835F4869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1961E4-4EBB-407E-A55B-3D2927BEA3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61D1E8-59C3-4765-A57E-10858951C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513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文本框 35"/>
          <p:cNvSpPr txBox="1"/>
          <p:nvPr/>
        </p:nvSpPr>
        <p:spPr>
          <a:xfrm>
            <a:off x="3625535" y="1927179"/>
            <a:ext cx="783030" cy="2226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47" dirty="0">
                <a:latin typeface="Arial" panose="020B0604020202020204" pitchFamily="34" charset="0"/>
                <a:cs typeface="Arial" panose="020B0604020202020204" pitchFamily="34" charset="0"/>
              </a:rPr>
              <a:t>Fig S1.</a:t>
            </a:r>
            <a:endParaRPr lang="zh-CN" altLang="en-US" sz="84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图表 37"/>
          <p:cNvGraphicFramePr>
            <a:graphicFrameLocks/>
          </p:cNvGraphicFramePr>
          <p:nvPr/>
        </p:nvGraphicFramePr>
        <p:xfrm>
          <a:off x="5589122" y="438534"/>
          <a:ext cx="918945" cy="11961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3" name="矩形 42"/>
          <p:cNvSpPr/>
          <p:nvPr/>
        </p:nvSpPr>
        <p:spPr>
          <a:xfrm>
            <a:off x="5752159" y="1557514"/>
            <a:ext cx="396262" cy="1704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508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508" dirty="0"/>
          </a:p>
        </p:txBody>
      </p:sp>
      <p:sp>
        <p:nvSpPr>
          <p:cNvPr id="44" name="矩形 43"/>
          <p:cNvSpPr/>
          <p:nvPr/>
        </p:nvSpPr>
        <p:spPr>
          <a:xfrm>
            <a:off x="6081214" y="1560740"/>
            <a:ext cx="478016" cy="1704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508" dirty="0">
                <a:latin typeface="Arial" panose="020B0604020202020204" pitchFamily="34" charset="0"/>
                <a:cs typeface="Arial" panose="020B0604020202020204" pitchFamily="34" charset="0"/>
              </a:rPr>
              <a:t>DAXX-KO</a:t>
            </a:r>
            <a:endParaRPr lang="zh-CN" altLang="en-US" sz="508" dirty="0"/>
          </a:p>
        </p:txBody>
      </p:sp>
      <p:sp>
        <p:nvSpPr>
          <p:cNvPr id="45" name="文本框 44"/>
          <p:cNvSpPr txBox="1"/>
          <p:nvPr/>
        </p:nvSpPr>
        <p:spPr>
          <a:xfrm>
            <a:off x="3477320" y="281309"/>
            <a:ext cx="333713" cy="2746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85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1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5576390" y="277008"/>
            <a:ext cx="333713" cy="2746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85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1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图表 13"/>
          <p:cNvGraphicFramePr>
            <a:graphicFrameLocks/>
          </p:cNvGraphicFramePr>
          <p:nvPr/>
        </p:nvGraphicFramePr>
        <p:xfrm>
          <a:off x="3746317" y="382976"/>
          <a:ext cx="1697160" cy="1339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3627685" y="2109896"/>
            <a:ext cx="2700186" cy="13958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47" dirty="0">
                <a:latin typeface="Arial" panose="020B0604020202020204" pitchFamily="34" charset="0"/>
                <a:cs typeface="Arial" panose="020B0604020202020204" pitchFamily="34" charset="0"/>
              </a:rPr>
              <a:t>In our paper, gene knock-out didn’t induce loss of rDNA copies. A. relative rDNA copy number was determined by average RPM of Input data. ATRX, DAXX or ESET knock-out ESC has the similar rDNA copy number with corresponding control. B. qPCR shows DAXX-KO(72h) didn’t change rDNA copy number in MEFs. DNA primers against 5’ETS was represented as rDNA copy, normalizing against DNA primers of GAPDH promoter. Three independent experiments were shown.</a:t>
            </a:r>
          </a:p>
        </p:txBody>
      </p:sp>
    </p:spTree>
    <p:extLst>
      <p:ext uri="{BB962C8B-B14F-4D97-AF65-F5344CB8AC3E}">
        <p14:creationId xmlns:p14="http://schemas.microsoft.com/office/powerpoint/2010/main" val="1625720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8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星卫 黄</dc:creator>
  <cp:lastModifiedBy>星卫 黄</cp:lastModifiedBy>
  <cp:revision>2</cp:revision>
  <dcterms:created xsi:type="dcterms:W3CDTF">2019-08-23T02:14:27Z</dcterms:created>
  <dcterms:modified xsi:type="dcterms:W3CDTF">2019-08-23T02:30:29Z</dcterms:modified>
</cp:coreProperties>
</file>